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3152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0" y="685440"/>
            <a:ext cx="6858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6A733D01-8653-49CE-89DD-C60C2246DDC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0" y="685800"/>
            <a:ext cx="685800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A87CFD59-CA52-4C98-A1C7-18EAC4084B6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19CEFC-4193-4D13-A62A-5E7FCC3E29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211428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66C27-0486-4AD7-8EA6-7B59D24FD5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222CCC-8FD1-411F-BCF8-0093B772DFD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B41C4D-807C-4634-9A69-63AE0A6241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5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EB85F-F048-4FA6-8789-40A61719AE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1F138-A1BD-48B9-A38C-89D7C5A947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6BB28-C6AD-45F8-BADB-A590D8DE1F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ACA66-B268-4C5F-8496-3CA23AEC92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145800"/>
            <a:ext cx="658512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50"/>
              </a:spcBef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7A325E-3783-4439-9BCE-04731D3E88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A3208C-D4E0-45DB-889C-310C6007B7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20D92-6DE3-48F2-8760-CBD79DA68D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D08BA-FF5A-47EF-85E4-685B0D3588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 fontScale="85000"/>
          </a:bodyPr>
          <a:p>
            <a:pPr marL="203760" indent="-20376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1" marL="442440" indent="-16956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2" marL="681120" indent="-13608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3" marL="954000" indent="-13644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4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5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6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3389400"/>
            <a:ext cx="170820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3389400"/>
            <a:ext cx="231768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3389400"/>
            <a:ext cx="170820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68EDAEF0-5EC2-40E3-9429-B7268878BD42}" type="slidenum">
              <a:rPr b="0" lang="en-US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5"/>
          <p:cNvSpPr/>
          <p:nvPr/>
        </p:nvSpPr>
        <p:spPr>
          <a:xfrm rot="10800000">
            <a:off x="-76320" y="914040"/>
            <a:ext cx="492120" cy="15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t" vert="eaVer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Percentage occurrenc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4"/>
          <p:cNvSpPr/>
          <p:nvPr/>
        </p:nvSpPr>
        <p:spPr>
          <a:xfrm>
            <a:off x="1622520" y="3378240"/>
            <a:ext cx="4473360" cy="25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t">
            <a:spAutoFit/>
          </a:bodyPr>
          <a:p>
            <a:pPr algn="ctr"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Stability of secondary structur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in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ematodes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, T=25</a:t>
            </a:r>
            <a:r>
              <a:rPr b="0" lang="en-US" sz="1100" spc="-1" strike="noStrike" baseline="50000">
                <a:solidFill>
                  <a:srgbClr val="000000"/>
                </a:solidFill>
                <a:latin typeface="Arial"/>
                <a:ea typeface="宋体"/>
              </a:rPr>
              <a:t>◦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C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 (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−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kcals/mol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8"/>
          <p:cNvSpPr/>
          <p:nvPr/>
        </p:nvSpPr>
        <p:spPr>
          <a:xfrm>
            <a:off x="201600" y="-19080"/>
            <a:ext cx="25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9"/>
          <p:cNvSpPr/>
          <p:nvPr/>
        </p:nvSpPr>
        <p:spPr>
          <a:xfrm>
            <a:off x="3630600" y="-19080"/>
            <a:ext cx="25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8"/>
          <p:cNvSpPr/>
          <p:nvPr/>
        </p:nvSpPr>
        <p:spPr>
          <a:xfrm>
            <a:off x="198000" y="1676520"/>
            <a:ext cx="25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9"/>
          <p:cNvSpPr/>
          <p:nvPr/>
        </p:nvSpPr>
        <p:spPr>
          <a:xfrm>
            <a:off x="3627000" y="1676520"/>
            <a:ext cx="25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2"/>
          <p:cNvSpPr/>
          <p:nvPr/>
        </p:nvSpPr>
        <p:spPr>
          <a:xfrm>
            <a:off x="3048120" y="30492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3"/>
          <p:cNvSpPr/>
          <p:nvPr/>
        </p:nvSpPr>
        <p:spPr>
          <a:xfrm>
            <a:off x="3084480" y="36972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4"/>
          <p:cNvSpPr/>
          <p:nvPr/>
        </p:nvSpPr>
        <p:spPr>
          <a:xfrm>
            <a:off x="3084480" y="52704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2"/>
          <p:cNvSpPr/>
          <p:nvPr/>
        </p:nvSpPr>
        <p:spPr>
          <a:xfrm>
            <a:off x="3048120" y="205740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3"/>
          <p:cNvSpPr/>
          <p:nvPr/>
        </p:nvSpPr>
        <p:spPr>
          <a:xfrm>
            <a:off x="3084480" y="212256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44"/>
          <p:cNvSpPr/>
          <p:nvPr/>
        </p:nvSpPr>
        <p:spPr>
          <a:xfrm>
            <a:off x="3084480" y="227952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42"/>
          <p:cNvSpPr/>
          <p:nvPr/>
        </p:nvSpPr>
        <p:spPr>
          <a:xfrm>
            <a:off x="6553080" y="30492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kip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3"/>
          <p:cNvSpPr/>
          <p:nvPr/>
        </p:nvSpPr>
        <p:spPr>
          <a:xfrm>
            <a:off x="6589800" y="36972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4"/>
          <p:cNvSpPr/>
          <p:nvPr/>
        </p:nvSpPr>
        <p:spPr>
          <a:xfrm>
            <a:off x="6589800" y="52704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42"/>
          <p:cNvSpPr/>
          <p:nvPr/>
        </p:nvSpPr>
        <p:spPr>
          <a:xfrm>
            <a:off x="6553080" y="205740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ki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3"/>
          <p:cNvSpPr/>
          <p:nvPr/>
        </p:nvSpPr>
        <p:spPr>
          <a:xfrm>
            <a:off x="6589800" y="212256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4"/>
          <p:cNvSpPr/>
          <p:nvPr/>
        </p:nvSpPr>
        <p:spPr>
          <a:xfrm>
            <a:off x="6589800" y="227952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25" descr=""/>
          <p:cNvPicPr/>
          <p:nvPr/>
        </p:nvPicPr>
        <p:blipFill>
          <a:blip r:embed="rId1"/>
          <a:srcRect l="0" t="34400" r="7925" b="23816"/>
          <a:stretch/>
        </p:blipFill>
        <p:spPr>
          <a:xfrm>
            <a:off x="247680" y="128520"/>
            <a:ext cx="3505320" cy="158760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26" descr=""/>
          <p:cNvPicPr/>
          <p:nvPr/>
        </p:nvPicPr>
        <p:blipFill>
          <a:blip r:embed="rId2"/>
          <a:srcRect l="0" t="34400" r="7925" b="23816"/>
          <a:stretch/>
        </p:blipFill>
        <p:spPr>
          <a:xfrm>
            <a:off x="3757680" y="128520"/>
            <a:ext cx="3506760" cy="158760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27" descr=""/>
          <p:cNvPicPr/>
          <p:nvPr/>
        </p:nvPicPr>
        <p:blipFill>
          <a:blip r:embed="rId3"/>
          <a:srcRect l="0" t="34400" r="7925" b="23816"/>
          <a:stretch/>
        </p:blipFill>
        <p:spPr>
          <a:xfrm>
            <a:off x="247680" y="1847880"/>
            <a:ext cx="3505320" cy="15876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28" descr=""/>
          <p:cNvPicPr/>
          <p:nvPr/>
        </p:nvPicPr>
        <p:blipFill>
          <a:blip r:embed="rId4"/>
          <a:srcRect l="0" t="34400" r="7925" b="23816"/>
          <a:stretch/>
        </p:blipFill>
        <p:spPr>
          <a:xfrm>
            <a:off x="3757680" y="1847880"/>
            <a:ext cx="3506760" cy="1587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liangchen</dc:creator>
  <dc:description/>
  <dc:language>en-US</dc:language>
  <cp:lastModifiedBy>USC College of Letters, Arts &amp; Sciences</cp:lastModifiedBy>
  <dcterms:modified xsi:type="dcterms:W3CDTF">2011-01-26T05:06:40Z</dcterms:modified>
  <cp:revision>53</cp:revision>
  <dc:subject/>
  <dc:title>Slide 1</dc:title>
</cp:coreProperties>
</file>